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980D1-8910-4625-BE2A-B20E35757C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3FC89-C7E5-4EDA-B483-58DAB14571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2FB25-AC91-468D-B853-28DE173ABE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FB709-5CFA-4489-8A78-A7C77B5645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FEFA0-108F-44C2-AB89-7C6BB603CF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2BCDB-1186-4B92-95F9-D7EE07D2BF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01CC9-65EC-410D-A4EE-5195A960EE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01046-11FC-48E7-A0E6-739829389B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32C04-5BBC-4CE4-B2B9-4CAEFD07F0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C4869-E863-40E0-A608-99C941276D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B3019-A887-4192-9F76-7F52D88EC0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008BE8-FA35-4BA9-9BA4-89D451EDF5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8560" y="272880"/>
            <a:ext cx="313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NL" sz="1200" spc="-1" strike="noStrike">
                <a:solidFill>
                  <a:srgbClr val="000000"/>
                </a:solidFill>
                <a:latin typeface="Arial"/>
              </a:rPr>
              <a:t>Kleemann et al., 2007, Additional data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76280" y="2265480"/>
          <a:ext cx="5470560" cy="4035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76280" y="2265480"/>
                    <a:ext cx="5470560" cy="4035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476280" y="826200"/>
            <a:ext cx="56894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data file 1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rrelation analysis between total plasma cholesterol levels and atherosclerosi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ponential positive correlation between atherosclerotic lesion area and total plasma cholesterol in female ApoE3Leiden mice. Animals were treated with diet T (see Method section) supplemented with cholesterol (0.25%, 0.35%, 0.40%, 0.75% and 1% w/w; n&gt;10 each) to achieve different plasma cholesterol leve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93911-6F1C-48F5-A66C-E67D8675F66E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3-16T09:17:31Z</dcterms:created>
  <dc:creator>verschl</dc:creator>
  <dc:description/>
  <dc:language>en-US</dc:language>
  <cp:lastModifiedBy>kleemannr</cp:lastModifiedBy>
  <dcterms:modified xsi:type="dcterms:W3CDTF">2007-07-13T10:14:53Z</dcterms:modified>
  <cp:revision>136</cp:revision>
  <dc:subject/>
  <dc:title>Dia 1</dc:title>
</cp:coreProperties>
</file>